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4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4BC70-67DB-4137-85A9-92C00BC25342}" type="datetimeFigureOut">
              <a:rPr lang="ko-KR" altLang="en-US" smtClean="0"/>
              <a:t>2015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A80D0-A11F-4858-BAB7-5B0DAE4193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642910" y="214290"/>
          <a:ext cx="6429420" cy="6429417"/>
        </p:xfrm>
        <a:graphic>
          <a:graphicData uri="http://schemas.openxmlformats.org/drawingml/2006/table">
            <a:tbl>
              <a:tblPr/>
              <a:tblGrid>
                <a:gridCol w="1695558"/>
                <a:gridCol w="1580078"/>
                <a:gridCol w="1803869"/>
                <a:gridCol w="1349915"/>
              </a:tblGrid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Pathologic finding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(+), n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(-), n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P value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Vacuole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20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2 ± 22.9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3.65 ± 22.5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83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0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9.83 ± 26.8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5.63 ± 22.82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87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R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8.67 ± 23.75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5.65 ± 17.3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744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eutrophil infiltration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19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32.89 ± 23.6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8.18 ± 20.21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075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0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9.33 ± 27.0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5.13 ± 21.7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80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R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4.78 ± 10.5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7.18 ± 21.89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458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Karyorrhexis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14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12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3.21 ± 20.91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3.33 ±24.5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8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0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33.08 ±28.85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9.67 ± 13.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145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R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9.14 ±19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3.08 ±18.2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376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Mucin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14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N=12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26.64 ±24.65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9.33 ± 19.1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494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L10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37.92 ±25.5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4.42 ± 12.68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0.01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8201"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  CXCR3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6.36 ± 14.78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latin typeface="Times New Roman"/>
                          <a:ea typeface="맑은 고딕"/>
                          <a:cs typeface="Times New Roman"/>
                        </a:rPr>
                        <a:t>16.33 ±22.87 </a:t>
                      </a:r>
                      <a:endParaRPr lang="ko-KR" sz="1200" kern="10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latin typeface="Times New Roman"/>
                          <a:ea typeface="맑은 고딕"/>
                          <a:cs typeface="Times New Roman"/>
                        </a:rPr>
                        <a:t>0.231 </a:t>
                      </a:r>
                      <a:endParaRPr lang="ko-KR" sz="1200" kern="100" dirty="0"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5167" marR="55167" marT="27584" marB="27584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9</Words>
  <Application>Microsoft Office PowerPoint</Application>
  <PresentationFormat>화면 슬라이드 쇼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Google</dc:creator>
  <cp:lastModifiedBy>Google</cp:lastModifiedBy>
  <cp:revision>2</cp:revision>
  <dcterms:created xsi:type="dcterms:W3CDTF">2015-08-07T01:41:15Z</dcterms:created>
  <dcterms:modified xsi:type="dcterms:W3CDTF">2015-08-07T01:42:48Z</dcterms:modified>
</cp:coreProperties>
</file>